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27" d="100"/>
          <a:sy n="127" d="100"/>
        </p:scale>
        <p:origin x="-112" y="-93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8AD8C-E328-7347-8D5F-D4F512082DAC}" type="datetimeFigureOut">
              <a:rPr lang="en-US" smtClean="0"/>
              <a:t>1/1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A29D-A0C8-354C-846F-9A76D3B44E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4459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8AD8C-E328-7347-8D5F-D4F512082DAC}" type="datetimeFigureOut">
              <a:rPr lang="en-US" smtClean="0"/>
              <a:t>1/1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A29D-A0C8-354C-846F-9A76D3B44E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7953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8AD8C-E328-7347-8D5F-D4F512082DAC}" type="datetimeFigureOut">
              <a:rPr lang="en-US" smtClean="0"/>
              <a:t>1/1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A29D-A0C8-354C-846F-9A76D3B44E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7221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8AD8C-E328-7347-8D5F-D4F512082DAC}" type="datetimeFigureOut">
              <a:rPr lang="en-US" smtClean="0"/>
              <a:t>1/1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A29D-A0C8-354C-846F-9A76D3B44E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726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8AD8C-E328-7347-8D5F-D4F512082DAC}" type="datetimeFigureOut">
              <a:rPr lang="en-US" smtClean="0"/>
              <a:t>1/1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A29D-A0C8-354C-846F-9A76D3B44E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69145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8AD8C-E328-7347-8D5F-D4F512082DAC}" type="datetimeFigureOut">
              <a:rPr lang="en-US" smtClean="0"/>
              <a:t>1/1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A29D-A0C8-354C-846F-9A76D3B44E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25084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8AD8C-E328-7347-8D5F-D4F512082DAC}" type="datetimeFigureOut">
              <a:rPr lang="en-US" smtClean="0"/>
              <a:t>1/15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A29D-A0C8-354C-846F-9A76D3B44E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640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8AD8C-E328-7347-8D5F-D4F512082DAC}" type="datetimeFigureOut">
              <a:rPr lang="en-US" smtClean="0"/>
              <a:t>1/15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A29D-A0C8-354C-846F-9A76D3B44E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7341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8AD8C-E328-7347-8D5F-D4F512082DAC}" type="datetimeFigureOut">
              <a:rPr lang="en-US" smtClean="0"/>
              <a:t>1/15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A29D-A0C8-354C-846F-9A76D3B44E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54734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8AD8C-E328-7347-8D5F-D4F512082DAC}" type="datetimeFigureOut">
              <a:rPr lang="en-US" smtClean="0"/>
              <a:t>1/1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A29D-A0C8-354C-846F-9A76D3B44E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9037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8AD8C-E328-7347-8D5F-D4F512082DAC}" type="datetimeFigureOut">
              <a:rPr lang="en-US" smtClean="0"/>
              <a:t>1/1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A29D-A0C8-354C-846F-9A76D3B44E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06292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78AD8C-E328-7347-8D5F-D4F512082DAC}" type="datetimeFigureOut">
              <a:rPr lang="en-US" smtClean="0"/>
              <a:t>1/1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5DA29D-A0C8-354C-846F-9A76D3B44E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1652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6514869"/>
              </p:ext>
            </p:extLst>
          </p:nvPr>
        </p:nvGraphicFramePr>
        <p:xfrm>
          <a:off x="1008479" y="877827"/>
          <a:ext cx="6667160" cy="5435034"/>
        </p:xfrm>
        <a:graphic>
          <a:graphicData uri="http://schemas.openxmlformats.org/drawingml/2006/table">
            <a:tbl>
              <a:tblPr/>
              <a:tblGrid>
                <a:gridCol w="1333432"/>
                <a:gridCol w="1333432"/>
                <a:gridCol w="1333432"/>
                <a:gridCol w="1333432"/>
                <a:gridCol w="1333432"/>
              </a:tblGrid>
              <a:tr h="247047">
                <a:tc gridSpan="5"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upplemental </a:t>
                      </a:r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ble </a:t>
                      </a:r>
                      <a:r>
                        <a:rPr lang="en-US" sz="14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 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es tested by 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RNA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inhibition. 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4704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704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BL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PHA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YN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TRK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NK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704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BL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PHB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C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TRK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X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704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NK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PHB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GF1R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DGFRA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YK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704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L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PHB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SR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DGFRB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YRO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704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XL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PHB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T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TK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704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L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PHB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AK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TK2B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ZAP7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704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MX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RBB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AK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TK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RA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704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T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RBB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AK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TK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RA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704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P53R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RBB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DR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TK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PHA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704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SF1R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ER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IT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TK9L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PHA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704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S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E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MTK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T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RM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704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DR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GFR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C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OR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AT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704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DR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GFR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T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OR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MTK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704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TYK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GFR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YN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OS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URVIVIN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704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GFR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GFR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T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Y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704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PHA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GR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RT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RC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704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PHA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LT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T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Y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704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PHA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LT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ST1R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EC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704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PHA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LT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US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E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704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PHA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R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TRK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I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93196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04</Words>
  <Application>Microsoft Macintosh PowerPoint</Application>
  <PresentationFormat>On-screen Show (4:3)</PresentationFormat>
  <Paragraphs>9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OHS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ssica Leonard</dc:creator>
  <cp:lastModifiedBy>Elie Traer</cp:lastModifiedBy>
  <cp:revision>2</cp:revision>
  <dcterms:created xsi:type="dcterms:W3CDTF">2016-01-11T06:18:02Z</dcterms:created>
  <dcterms:modified xsi:type="dcterms:W3CDTF">2016-01-16T02:05:56Z</dcterms:modified>
</cp:coreProperties>
</file>